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1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955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213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59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941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002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019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427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343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097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874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222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18A8B-FA77-4B57-B18D-6D10530A760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014556-55FA-4593-87C2-1AE06EBBB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424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550" y="3429000"/>
            <a:ext cx="3291840" cy="329433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7" name="Picture 3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72158"/>
            <a:ext cx="3291840" cy="31089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6" name="Picture 2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7740" y="184296"/>
            <a:ext cx="3291840" cy="312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4594860" y="4572000"/>
            <a:ext cx="3352800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SF3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itam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 mediated changes in the expression of genes in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esicula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gulatory network in 143B human OS cells during proliferation (A), post-proliferation (B), and differentiation (C). The yellow color denotes transcription factors while the green and red color indicate vitamin D induced down and up regulated genes, respectively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14400" y="15240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95800" y="11864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914400" y="33528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993566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2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eteran Affai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imella, Rama (KCVA)</dc:creator>
  <cp:lastModifiedBy>Garimella, Rama (KCVA)</cp:lastModifiedBy>
  <cp:revision>4</cp:revision>
  <dcterms:created xsi:type="dcterms:W3CDTF">2016-03-21T19:01:17Z</dcterms:created>
  <dcterms:modified xsi:type="dcterms:W3CDTF">2017-03-14T17:46:28Z</dcterms:modified>
</cp:coreProperties>
</file>